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6" r:id="rId2"/>
  </p:sldIdLst>
  <p:sldSz cx="9144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97" autoAdjust="0"/>
    <p:restoredTop sz="94660"/>
  </p:normalViewPr>
  <p:slideViewPr>
    <p:cSldViewPr snapToGrid="0">
      <p:cViewPr>
        <p:scale>
          <a:sx n="70" d="100"/>
          <a:sy n="70" d="100"/>
        </p:scale>
        <p:origin x="1368" y="-5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995312"/>
            <a:ext cx="7772400" cy="4244622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6403623"/>
            <a:ext cx="6858000" cy="2943577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E38550-314A-4C66-BDAF-C366053B0A59}" type="datetimeFigureOut">
              <a:rPr lang="en-GB" smtClean="0"/>
              <a:t>10/0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F4671-4BE7-4229-9BA4-33850815D8C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826683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E38550-314A-4C66-BDAF-C366053B0A59}" type="datetimeFigureOut">
              <a:rPr lang="en-GB" smtClean="0"/>
              <a:t>10/0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F4671-4BE7-4229-9BA4-33850815D8C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848769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649111"/>
            <a:ext cx="1971675" cy="10332156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649111"/>
            <a:ext cx="5800725" cy="10332156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E38550-314A-4C66-BDAF-C366053B0A59}" type="datetimeFigureOut">
              <a:rPr lang="en-GB" smtClean="0"/>
              <a:t>10/0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F4671-4BE7-4229-9BA4-33850815D8C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133450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E38550-314A-4C66-BDAF-C366053B0A59}" type="datetimeFigureOut">
              <a:rPr lang="en-GB" smtClean="0"/>
              <a:t>10/0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F4671-4BE7-4229-9BA4-33850815D8C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96578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3039537"/>
            <a:ext cx="7886700" cy="5071532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8159048"/>
            <a:ext cx="7886700" cy="2666999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E38550-314A-4C66-BDAF-C366053B0A59}" type="datetimeFigureOut">
              <a:rPr lang="en-GB" smtClean="0"/>
              <a:t>10/0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F4671-4BE7-4229-9BA4-33850815D8C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058767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3245556"/>
            <a:ext cx="3886200" cy="7735712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3245556"/>
            <a:ext cx="3886200" cy="7735712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E38550-314A-4C66-BDAF-C366053B0A59}" type="datetimeFigureOut">
              <a:rPr lang="en-GB" smtClean="0"/>
              <a:t>10/01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F4671-4BE7-4229-9BA4-33850815D8C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567061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649114"/>
            <a:ext cx="7886700" cy="2356556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2988734"/>
            <a:ext cx="3868340" cy="146473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4453467"/>
            <a:ext cx="3868340" cy="6550379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2988734"/>
            <a:ext cx="3887391" cy="146473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4453467"/>
            <a:ext cx="3887391" cy="6550379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E38550-314A-4C66-BDAF-C366053B0A59}" type="datetimeFigureOut">
              <a:rPr lang="en-GB" smtClean="0"/>
              <a:t>10/01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F4671-4BE7-4229-9BA4-33850815D8C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158315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E38550-314A-4C66-BDAF-C366053B0A59}" type="datetimeFigureOut">
              <a:rPr lang="en-GB" smtClean="0"/>
              <a:t>10/01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F4671-4BE7-4229-9BA4-33850815D8C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360843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E38550-314A-4C66-BDAF-C366053B0A59}" type="datetimeFigureOut">
              <a:rPr lang="en-GB" smtClean="0"/>
              <a:t>10/01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F4671-4BE7-4229-9BA4-33850815D8C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073369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812800"/>
            <a:ext cx="2949178" cy="28448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1755425"/>
            <a:ext cx="4629150" cy="8664222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3657600"/>
            <a:ext cx="2949178" cy="6776156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E38550-314A-4C66-BDAF-C366053B0A59}" type="datetimeFigureOut">
              <a:rPr lang="en-GB" smtClean="0"/>
              <a:t>10/01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F4671-4BE7-4229-9BA4-33850815D8C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33865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812800"/>
            <a:ext cx="2949178" cy="28448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1755425"/>
            <a:ext cx="4629150" cy="8664222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3657600"/>
            <a:ext cx="2949178" cy="6776156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E38550-314A-4C66-BDAF-C366053B0A59}" type="datetimeFigureOut">
              <a:rPr lang="en-GB" smtClean="0"/>
              <a:t>10/01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F4671-4BE7-4229-9BA4-33850815D8C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818638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649114"/>
            <a:ext cx="7886700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3245556"/>
            <a:ext cx="7886700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11300181"/>
            <a:ext cx="20574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E38550-314A-4C66-BDAF-C366053B0A59}" type="datetimeFigureOut">
              <a:rPr lang="en-GB" smtClean="0"/>
              <a:t>10/0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11300181"/>
            <a:ext cx="30861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11300181"/>
            <a:ext cx="20574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2F4671-4BE7-4229-9BA4-33850815D8C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2890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el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95330351"/>
              </p:ext>
            </p:extLst>
          </p:nvPr>
        </p:nvGraphicFramePr>
        <p:xfrm>
          <a:off x="2941838" y="2008087"/>
          <a:ext cx="3136604" cy="57150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862174">
                  <a:extLst>
                    <a:ext uri="{9D8B030D-6E8A-4147-A177-3AD203B41FA5}">
                      <a16:colId xmlns:a16="http://schemas.microsoft.com/office/drawing/2014/main" xmlns="" val="1119140237"/>
                    </a:ext>
                  </a:extLst>
                </a:gridCol>
                <a:gridCol w="1274430">
                  <a:extLst>
                    <a:ext uri="{9D8B030D-6E8A-4147-A177-3AD203B41FA5}">
                      <a16:colId xmlns:a16="http://schemas.microsoft.com/office/drawing/2014/main" xmlns="" val="3095648534"/>
                    </a:ext>
                  </a:extLst>
                </a:gridCol>
              </a:tblGrid>
              <a:tr h="297180">
                <a:tc>
                  <a:txBody>
                    <a:bodyPr/>
                    <a:lstStyle/>
                    <a:p>
                      <a:r>
                        <a:rPr lang="de-DE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-10 </a:t>
                      </a:r>
                      <a:r>
                        <a:rPr lang="de-DE" sz="1200" dirty="0" err="1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menclature</a:t>
                      </a:r>
                      <a:endParaRPr lang="de-DE" sz="12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r>
                        <a:rPr lang="de-DE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de-DE" sz="1200" dirty="0" err="1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is</a:t>
                      </a:r>
                      <a:r>
                        <a:rPr lang="de-DE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de-DE" sz="1200" dirty="0" err="1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udy</a:t>
                      </a:r>
                      <a:r>
                        <a:rPr lang="de-DE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en-GB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 </a:t>
                      </a:r>
                      <a:r>
                        <a:rPr lang="de-DE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mber</a:t>
                      </a:r>
                      <a:endParaRPr lang="en-GB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261630841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r>
                        <a:rPr lang="de-DE" sz="1200" i="1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01</a:t>
                      </a:r>
                      <a:endParaRPr lang="en-GB" sz="1200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i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07080</a:t>
                      </a:r>
                      <a:endParaRPr lang="en-GB" sz="1200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763243036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r>
                        <a:rPr lang="de-DE" sz="1200" i="1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02</a:t>
                      </a:r>
                      <a:endParaRPr lang="en-GB" sz="1200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1200" i="1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07086</a:t>
                      </a:r>
                      <a:endParaRPr lang="en-GB" sz="1200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695429828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r>
                        <a:rPr lang="de-DE" sz="1200" i="1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03</a:t>
                      </a:r>
                      <a:endParaRPr lang="en-GB" sz="1200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200" i="1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07082</a:t>
                      </a:r>
                      <a:endParaRPr lang="en-GB" sz="1200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18702776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r>
                        <a:rPr lang="de-DE" sz="1200" i="1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04</a:t>
                      </a:r>
                      <a:endParaRPr lang="en-GB" sz="1200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200" i="1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05122</a:t>
                      </a:r>
                      <a:endParaRPr lang="en-GB" sz="1200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636594856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r>
                        <a:rPr lang="de-DE" sz="1200" i="1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05</a:t>
                      </a:r>
                      <a:endParaRPr lang="en-GB" sz="1200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200" i="1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07065</a:t>
                      </a:r>
                      <a:endParaRPr lang="en-GB" sz="1200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611181689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r>
                        <a:rPr lang="de-DE" sz="1200" i="1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06</a:t>
                      </a:r>
                      <a:endParaRPr lang="en-GB" sz="1200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200" i="1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07088</a:t>
                      </a:r>
                      <a:endParaRPr lang="en-GB" sz="1200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558090850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r>
                        <a:rPr lang="de-DE" sz="1200" i="1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07</a:t>
                      </a:r>
                      <a:endParaRPr lang="en-GB" sz="1200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200" i="1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05123</a:t>
                      </a:r>
                      <a:endParaRPr lang="en-GB" sz="1200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338417272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r>
                        <a:rPr lang="de-DE" sz="1200" i="1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08</a:t>
                      </a:r>
                      <a:endParaRPr lang="en-GB" sz="1200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200" i="1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07064</a:t>
                      </a:r>
                      <a:endParaRPr lang="en-GB" sz="1200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335713480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r>
                        <a:rPr lang="de-DE" sz="1200" i="1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09</a:t>
                      </a:r>
                      <a:endParaRPr lang="en-GB" sz="1200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200" i="1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07084</a:t>
                      </a:r>
                      <a:endParaRPr lang="en-GB" sz="1200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792258769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r>
                        <a:rPr lang="de-DE" sz="1200" i="1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10</a:t>
                      </a:r>
                      <a:endParaRPr lang="en-GB" sz="1200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200" i="1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07087</a:t>
                      </a:r>
                      <a:endParaRPr lang="en-GB" sz="1200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143512458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r>
                        <a:rPr lang="de-DE" sz="1200" i="1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11</a:t>
                      </a:r>
                      <a:endParaRPr lang="en-GB" sz="1200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200" i="1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07083</a:t>
                      </a:r>
                      <a:endParaRPr lang="en-GB" sz="1200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512514387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r>
                        <a:rPr lang="de-DE" sz="1200" i="1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12</a:t>
                      </a:r>
                      <a:endParaRPr lang="en-GB" sz="1200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200" i="1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07085</a:t>
                      </a:r>
                      <a:endParaRPr lang="en-GB" sz="1200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719479537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r>
                        <a:rPr lang="de-DE" sz="1200" i="1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13</a:t>
                      </a:r>
                      <a:endParaRPr lang="en-GB" sz="1200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200" i="1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32299</a:t>
                      </a:r>
                      <a:endParaRPr lang="en-GB" sz="1200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71604948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r>
                        <a:rPr lang="de-DE" sz="1200" i="1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14</a:t>
                      </a:r>
                      <a:endParaRPr lang="en-GB" sz="1200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200" i="1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07063</a:t>
                      </a:r>
                      <a:endParaRPr lang="en-GB" sz="1200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450454197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r>
                        <a:rPr lang="de-DE" sz="1200" i="1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15</a:t>
                      </a:r>
                      <a:endParaRPr lang="en-GB" sz="1200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200" i="1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04962</a:t>
                      </a:r>
                      <a:endParaRPr lang="en-GB" sz="1200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911613815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r>
                        <a:rPr lang="de-DE" sz="1200" i="1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16</a:t>
                      </a:r>
                      <a:endParaRPr lang="en-GB" sz="1200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200" i="1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07081</a:t>
                      </a:r>
                      <a:endParaRPr lang="en-GB" sz="1200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748524674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r>
                        <a:rPr lang="de-DE" sz="1200" i="1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17</a:t>
                      </a:r>
                      <a:endParaRPr lang="en-GB" sz="1200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200" i="1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05185</a:t>
                      </a:r>
                      <a:endParaRPr lang="en-GB" sz="1200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553417981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r>
                        <a:rPr lang="de-DE" sz="1200" i="1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18</a:t>
                      </a:r>
                      <a:endParaRPr lang="en-GB" sz="1200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200" i="1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07077</a:t>
                      </a:r>
                      <a:endParaRPr lang="en-GB" sz="1200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291619120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r>
                        <a:rPr lang="de-DE" sz="1200" i="1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19</a:t>
                      </a:r>
                      <a:endParaRPr lang="en-GB" sz="1200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200" i="1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11094</a:t>
                      </a:r>
                      <a:endParaRPr lang="en-GB" sz="1200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295405101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r>
                        <a:rPr lang="de-DE" sz="1200" i="1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20</a:t>
                      </a:r>
                      <a:endParaRPr lang="en-GB" sz="1200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200" i="1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07076</a:t>
                      </a:r>
                      <a:endParaRPr lang="en-GB" sz="1200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931099742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r>
                        <a:rPr lang="de-DE" sz="1200" i="1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21</a:t>
                      </a:r>
                      <a:endParaRPr lang="en-GB" sz="1200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200" i="1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07078</a:t>
                      </a:r>
                      <a:endParaRPr lang="en-GB" sz="1200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34290" marB="3429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907638607"/>
                  </a:ext>
                </a:extLst>
              </a:tr>
            </a:tbl>
          </a:graphicData>
        </a:graphic>
      </p:graphicFrame>
      <p:sp>
        <p:nvSpPr>
          <p:cNvPr id="6" name="Textfeld 5"/>
          <p:cNvSpPr txBox="1"/>
          <p:nvPr/>
        </p:nvSpPr>
        <p:spPr>
          <a:xfrm>
            <a:off x="2941838" y="1484867"/>
            <a:ext cx="313660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2. 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-10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omenclatur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en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umber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769683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59</Words>
  <Application>Microsoft Office PowerPoint</Application>
  <PresentationFormat>Custom</PresentationFormat>
  <Paragraphs>4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</vt:lpstr>
      <vt:lpstr>PowerPoint Presentation</vt:lpstr>
    </vt:vector>
  </TitlesOfParts>
  <Company>Hewlett-Packard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Wilfried Schwab</dc:creator>
  <cp:lastModifiedBy>mhahca</cp:lastModifiedBy>
  <cp:revision>14</cp:revision>
  <dcterms:created xsi:type="dcterms:W3CDTF">2018-07-30T10:23:00Z</dcterms:created>
  <dcterms:modified xsi:type="dcterms:W3CDTF">2019-01-10T13:59:19Z</dcterms:modified>
</cp:coreProperties>
</file>